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67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77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356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378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510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40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6412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653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4722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7371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982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3D4F7-D06C-4CB6-9279-5C78FBA3FB3F}" type="datetimeFigureOut">
              <a:rPr lang="zh-CN" altLang="en-US" smtClean="0"/>
              <a:t>2021/3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FDF79-8FF1-4025-BF7D-9DDDF49370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2815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4460856"/>
              </p:ext>
            </p:extLst>
          </p:nvPr>
        </p:nvGraphicFramePr>
        <p:xfrm>
          <a:off x="901338" y="964857"/>
          <a:ext cx="10280468" cy="4532815"/>
        </p:xfrm>
        <a:graphic>
          <a:graphicData uri="http://schemas.openxmlformats.org/drawingml/2006/table">
            <a:tbl>
              <a:tblPr firstRow="1" firstCol="1" bandRow="1"/>
              <a:tblGrid>
                <a:gridCol w="4832504">
                  <a:extLst>
                    <a:ext uri="{9D8B030D-6E8A-4147-A177-3AD203B41FA5}">
                      <a16:colId xmlns:a16="http://schemas.microsoft.com/office/drawing/2014/main" val="593765658"/>
                    </a:ext>
                  </a:extLst>
                </a:gridCol>
                <a:gridCol w="2810277">
                  <a:extLst>
                    <a:ext uri="{9D8B030D-6E8A-4147-A177-3AD203B41FA5}">
                      <a16:colId xmlns:a16="http://schemas.microsoft.com/office/drawing/2014/main" val="2689402488"/>
                    </a:ext>
                  </a:extLst>
                </a:gridCol>
                <a:gridCol w="2637687">
                  <a:extLst>
                    <a:ext uri="{9D8B030D-6E8A-4147-A177-3AD203B41FA5}">
                      <a16:colId xmlns:a16="http://schemas.microsoft.com/office/drawing/2014/main" val="2188003911"/>
                    </a:ext>
                  </a:extLst>
                </a:gridCol>
              </a:tblGrid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CN" sz="18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1D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D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711969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8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8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8300424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ge </a:t>
                      </a:r>
                      <a:r>
                        <a:rPr lang="en-US" sz="1800" b="1" kern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t time of blood donation (years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0.4±11.3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0.8±11.6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0365312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ender (M/F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9/39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9/39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6802571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ge at </a:t>
                      </a:r>
                      <a:r>
                        <a:rPr lang="en-US" sz="1800" b="1" kern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iagnosis </a:t>
                      </a:r>
                      <a:r>
                        <a:rPr lang="en-US" altLang="zh-CN" sz="1800" b="1" kern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years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9.5±8.9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1842836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uration </a:t>
                      </a:r>
                      <a:r>
                        <a:rPr lang="en-US" altLang="zh-CN" sz="1800" b="1" kern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(years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.8 (1.5-16.8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7933553"/>
                  </a:ext>
                </a:extLst>
              </a:tr>
              <a:tr h="34333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utoantibody positive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3921728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ZnT8A (%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6 (38.2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4827349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ADA (%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0 (58.8)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7137024"/>
                  </a:ext>
                </a:extLst>
              </a:tr>
              <a:tr h="40873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A-2A (%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3 (33.8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6339733"/>
                  </a:ext>
                </a:extLst>
              </a:tr>
              <a:tr h="5109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AA (%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3 (63.2)</a:t>
                      </a:r>
                      <a:endParaRPr lang="zh-CN" sz="18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zh-CN" sz="18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999616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901338" y="5687547"/>
            <a:ext cx="10280468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ote: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, male, F, female. HD, healthy donor.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ge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t time of blood </a:t>
            </a:r>
            <a:r>
              <a:rPr lang="en-US" altLang="zh-CN" sz="16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onation and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ge at T1D diagnosis are shown as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ean ± SD. T1D disease duration is shown as median and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quartile. T1D individuals were treated with insulin injection, and none of them were under immune therapy</a:t>
            </a:r>
            <a:r>
              <a:rPr kumimoji="0" lang="en-US" altLang="zh-CN" sz="16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before. Both healthy controls and T1D individuals </a:t>
            </a:r>
            <a:r>
              <a:rPr lang="en-US" altLang="zh-CN" sz="1600" dirty="0" smtClean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ere </a:t>
            </a:r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ree of infections at the time of </a:t>
            </a:r>
            <a:r>
              <a:rPr lang="en-US" altLang="zh-CN" sz="1600" dirty="0" smtClean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lood donation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1783227" y="313317"/>
            <a:ext cx="85166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linical characteristics of the study population 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056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045" y="1177290"/>
            <a:ext cx="5811120" cy="370507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2572" y="1082708"/>
            <a:ext cx="5579662" cy="379965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313066" y="4882366"/>
            <a:ext cx="7737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187616" y="4882365"/>
            <a:ext cx="7737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0" y="31891"/>
            <a:ext cx="21815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86392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9858" y="229974"/>
            <a:ext cx="9102681" cy="662802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31891"/>
            <a:ext cx="21815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1785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31891"/>
            <a:ext cx="21815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702" y="600317"/>
            <a:ext cx="11181807" cy="6213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5274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167</Words>
  <Application>Microsoft Office PowerPoint</Application>
  <PresentationFormat>宽屏</PresentationFormat>
  <Paragraphs>4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>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uanfeng Xu</dc:creator>
  <cp:lastModifiedBy>Kuanfeng Xu</cp:lastModifiedBy>
  <cp:revision>8</cp:revision>
  <dcterms:created xsi:type="dcterms:W3CDTF">2020-11-12T03:18:49Z</dcterms:created>
  <dcterms:modified xsi:type="dcterms:W3CDTF">2021-03-30T01:25:09Z</dcterms:modified>
</cp:coreProperties>
</file>